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A5CB7D-7438-4540-846D-84F331181A2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E44284-1751-4718-80BB-511F23ED71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7427F1-BC94-4411-94D8-9BC43CDDB9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8BFB40-D54C-4CFC-8FE9-BCA7ECF251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97EE7-E67A-4E4B-B06E-DCAB6D68F2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77B246-EEC8-4CFD-A00B-8B65370D13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42193A-EA0F-4F0B-A38B-715586EBAB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C4E72-885E-4431-A6C3-8A24D50C92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09174-4268-4166-8F11-899EFB80C1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706DC3-24DE-4008-AD68-906D1ACC8E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212D2E-B34D-4E9B-9F4B-FDBE2687F9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6CC3A-DC91-4CD7-9188-DCC25067C0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33464E-B526-43B1-B21A-093CDE7250D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76160" y="4730760"/>
            <a:ext cx="312840" cy="0"/>
          </a:xfrm>
          <a:prstGeom prst="line">
            <a:avLst/>
          </a:prstGeom>
          <a:ln cap="rnd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876960" y="477360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0.1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844880" y="6435720"/>
            <a:ext cx="8280" cy="42840"/>
          </a:xfrm>
          <a:custGeom>
            <a:avLst/>
            <a:gdLst/>
            <a:ahLst/>
            <a:rect l="l" t="t" r="r" b="b"/>
            <a:pathLst>
              <a:path w="22" h="91">
                <a:moveTo>
                  <a:pt x="22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384880" y="4732200"/>
            <a:ext cx="128520" cy="44640"/>
          </a:xfrm>
          <a:custGeom>
            <a:avLst/>
            <a:gdLst/>
            <a:ahLst/>
            <a:rect l="l" t="t" r="r" b="b"/>
            <a:pathLst>
              <a:path w="320" h="91">
                <a:moveTo>
                  <a:pt x="320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805200" y="3203640"/>
            <a:ext cx="860400" cy="44280"/>
          </a:xfrm>
          <a:custGeom>
            <a:avLst/>
            <a:gdLst/>
            <a:ahLst/>
            <a:rect l="l" t="t" r="r" b="b"/>
            <a:pathLst>
              <a:path w="2150" h="91">
                <a:moveTo>
                  <a:pt x="2150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451400" y="4548240"/>
            <a:ext cx="120600" cy="295200"/>
          </a:xfrm>
          <a:custGeom>
            <a:avLst/>
            <a:gdLst/>
            <a:ahLst/>
            <a:rect l="l" t="t" r="r" b="b"/>
            <a:pathLst>
              <a:path w="303" h="615">
                <a:moveTo>
                  <a:pt x="303" y="615"/>
                </a:moveTo>
                <a:lnTo>
                  <a:pt x="0" y="615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000680" y="2025720"/>
            <a:ext cx="201600" cy="65160"/>
          </a:xfrm>
          <a:custGeom>
            <a:avLst/>
            <a:gdLst/>
            <a:ahLst/>
            <a:rect l="l" t="t" r="r" b="b"/>
            <a:pathLst>
              <a:path w="506" h="136">
                <a:moveTo>
                  <a:pt x="506" y="0"/>
                </a:moveTo>
                <a:lnTo>
                  <a:pt x="0" y="0"/>
                </a:lnTo>
                <a:lnTo>
                  <a:pt x="0" y="136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965400" y="2446200"/>
            <a:ext cx="625680" cy="157320"/>
          </a:xfrm>
          <a:custGeom>
            <a:avLst/>
            <a:gdLst/>
            <a:ahLst/>
            <a:rect l="l" t="t" r="r" b="b"/>
            <a:pathLst>
              <a:path w="1561" h="330">
                <a:moveTo>
                  <a:pt x="1561" y="330"/>
                </a:moveTo>
                <a:lnTo>
                  <a:pt x="0" y="330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572000" y="6200640"/>
            <a:ext cx="95400" cy="103320"/>
          </a:xfrm>
          <a:custGeom>
            <a:avLst/>
            <a:gdLst/>
            <a:ahLst/>
            <a:rect l="l" t="t" r="r" b="b"/>
            <a:pathLst>
              <a:path w="237" h="216">
                <a:moveTo>
                  <a:pt x="237" y="216"/>
                </a:moveTo>
                <a:lnTo>
                  <a:pt x="0" y="216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664160" y="6019920"/>
            <a:ext cx="17280" cy="75960"/>
          </a:xfrm>
          <a:custGeom>
            <a:avLst/>
            <a:gdLst/>
            <a:ahLst/>
            <a:rect l="l" t="t" r="r" b="b"/>
            <a:pathLst>
              <a:path w="44" h="159">
                <a:moveTo>
                  <a:pt x="44" y="0"/>
                </a:moveTo>
                <a:lnTo>
                  <a:pt x="0" y="0"/>
                </a:lnTo>
                <a:lnTo>
                  <a:pt x="0" y="159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235480" y="5081760"/>
            <a:ext cx="198360" cy="42840"/>
          </a:xfrm>
          <a:custGeom>
            <a:avLst/>
            <a:gdLst/>
            <a:ahLst/>
            <a:rect l="l" t="t" r="r" b="b"/>
            <a:pathLst>
              <a:path w="496" h="91">
                <a:moveTo>
                  <a:pt x="496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630680" y="1566720"/>
            <a:ext cx="216000" cy="98640"/>
          </a:xfrm>
          <a:custGeom>
            <a:avLst/>
            <a:gdLst/>
            <a:ahLst/>
            <a:rect l="l" t="t" r="r" b="b"/>
            <a:pathLst>
              <a:path w="541" h="204">
                <a:moveTo>
                  <a:pt x="541" y="0"/>
                </a:moveTo>
                <a:lnTo>
                  <a:pt x="0" y="0"/>
                </a:lnTo>
                <a:lnTo>
                  <a:pt x="0" y="204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071960" y="5605560"/>
            <a:ext cx="266760" cy="87120"/>
          </a:xfrm>
          <a:custGeom>
            <a:avLst/>
            <a:gdLst/>
            <a:ahLst/>
            <a:rect l="l" t="t" r="r" b="b"/>
            <a:pathLst>
              <a:path w="669" h="182">
                <a:moveTo>
                  <a:pt x="669" y="0"/>
                </a:moveTo>
                <a:lnTo>
                  <a:pt x="0" y="0"/>
                </a:lnTo>
                <a:lnTo>
                  <a:pt x="0" y="182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849920" y="5048280"/>
            <a:ext cx="215640" cy="127080"/>
          </a:xfrm>
          <a:custGeom>
            <a:avLst/>
            <a:gdLst/>
            <a:ahLst/>
            <a:rect l="l" t="t" r="r" b="b"/>
            <a:pathLst>
              <a:path w="541" h="262">
                <a:moveTo>
                  <a:pt x="541" y="0"/>
                </a:moveTo>
                <a:lnTo>
                  <a:pt x="0" y="0"/>
                </a:lnTo>
                <a:lnTo>
                  <a:pt x="0" y="262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611520" y="2468520"/>
            <a:ext cx="1635120" cy="343080"/>
          </a:xfrm>
          <a:custGeom>
            <a:avLst/>
            <a:gdLst/>
            <a:ahLst/>
            <a:rect l="l" t="t" r="r" b="b"/>
            <a:pathLst>
              <a:path w="4089" h="714">
                <a:moveTo>
                  <a:pt x="4089" y="714"/>
                </a:moveTo>
                <a:lnTo>
                  <a:pt x="0" y="714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246640" y="2811600"/>
            <a:ext cx="36720" cy="42840"/>
          </a:xfrm>
          <a:custGeom>
            <a:avLst/>
            <a:gdLst/>
            <a:ahLst/>
            <a:rect l="l" t="t" r="r" b="b"/>
            <a:pathLst>
              <a:path w="90" h="91">
                <a:moveTo>
                  <a:pt x="90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965840" y="2417760"/>
            <a:ext cx="528480" cy="44280"/>
          </a:xfrm>
          <a:custGeom>
            <a:avLst/>
            <a:gdLst/>
            <a:ahLst/>
            <a:rect l="l" t="t" r="r" b="b"/>
            <a:pathLst>
              <a:path w="1322" h="91">
                <a:moveTo>
                  <a:pt x="1322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705200" y="1282680"/>
            <a:ext cx="527040" cy="44640"/>
          </a:xfrm>
          <a:custGeom>
            <a:avLst/>
            <a:gdLst/>
            <a:ahLst/>
            <a:rect l="l" t="t" r="r" b="b"/>
            <a:pathLst>
              <a:path w="1317" h="91">
                <a:moveTo>
                  <a:pt x="1317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664160" y="6095880"/>
            <a:ext cx="27000" cy="76320"/>
          </a:xfrm>
          <a:custGeom>
            <a:avLst/>
            <a:gdLst/>
            <a:ahLst/>
            <a:rect l="l" t="t" r="r" b="b"/>
            <a:pathLst>
              <a:path w="69" h="159">
                <a:moveTo>
                  <a:pt x="69" y="159"/>
                </a:moveTo>
                <a:lnTo>
                  <a:pt x="0" y="159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697280" y="5954760"/>
            <a:ext cx="1800" cy="42840"/>
          </a:xfrm>
          <a:custGeom>
            <a:avLst/>
            <a:gdLst/>
            <a:ahLst/>
            <a:rect l="l" t="t" r="r" b="b"/>
            <a:pathLst>
              <a:path w="1" h="91">
                <a:moveTo>
                  <a:pt x="1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965400" y="2287440"/>
            <a:ext cx="138240" cy="158760"/>
          </a:xfrm>
          <a:custGeom>
            <a:avLst/>
            <a:gdLst/>
            <a:ahLst/>
            <a:rect l="l" t="t" r="r" b="b"/>
            <a:pathLst>
              <a:path w="344" h="330">
                <a:moveTo>
                  <a:pt x="344" y="0"/>
                </a:moveTo>
                <a:lnTo>
                  <a:pt x="0" y="0"/>
                </a:lnTo>
                <a:lnTo>
                  <a:pt x="0" y="33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381560" y="4121280"/>
            <a:ext cx="147600" cy="212760"/>
          </a:xfrm>
          <a:custGeom>
            <a:avLst/>
            <a:gdLst/>
            <a:ahLst/>
            <a:rect l="l" t="t" r="r" b="b"/>
            <a:pathLst>
              <a:path w="367" h="444">
                <a:moveTo>
                  <a:pt x="367" y="0"/>
                </a:moveTo>
                <a:lnTo>
                  <a:pt x="0" y="0"/>
                </a:lnTo>
                <a:lnTo>
                  <a:pt x="0" y="444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572000" y="4843440"/>
            <a:ext cx="119160" cy="458640"/>
          </a:xfrm>
          <a:custGeom>
            <a:avLst/>
            <a:gdLst/>
            <a:ahLst/>
            <a:rect l="l" t="t" r="r" b="b"/>
            <a:pathLst>
              <a:path w="294" h="958">
                <a:moveTo>
                  <a:pt x="294" y="958"/>
                </a:moveTo>
                <a:lnTo>
                  <a:pt x="0" y="958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065560" y="4884840"/>
            <a:ext cx="113040" cy="163440"/>
          </a:xfrm>
          <a:custGeom>
            <a:avLst/>
            <a:gdLst/>
            <a:ahLst/>
            <a:rect l="l" t="t" r="r" b="b"/>
            <a:pathLst>
              <a:path w="282" h="341">
                <a:moveTo>
                  <a:pt x="282" y="0"/>
                </a:moveTo>
                <a:lnTo>
                  <a:pt x="0" y="0"/>
                </a:lnTo>
                <a:lnTo>
                  <a:pt x="0" y="34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079960" y="4383000"/>
            <a:ext cx="166680" cy="42840"/>
          </a:xfrm>
          <a:custGeom>
            <a:avLst/>
            <a:gdLst/>
            <a:ahLst/>
            <a:rect l="l" t="t" r="r" b="b"/>
            <a:pathLst>
              <a:path w="418" h="91">
                <a:moveTo>
                  <a:pt x="418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5065560" y="5048280"/>
            <a:ext cx="306720" cy="163440"/>
          </a:xfrm>
          <a:custGeom>
            <a:avLst/>
            <a:gdLst/>
            <a:ahLst/>
            <a:rect l="l" t="t" r="r" b="b"/>
            <a:pathLst>
              <a:path w="766" h="341">
                <a:moveTo>
                  <a:pt x="766" y="341"/>
                </a:moveTo>
                <a:lnTo>
                  <a:pt x="0" y="34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754520" y="3552840"/>
            <a:ext cx="854280" cy="44280"/>
          </a:xfrm>
          <a:custGeom>
            <a:avLst/>
            <a:gdLst/>
            <a:ahLst/>
            <a:rect l="l" t="t" r="r" b="b"/>
            <a:pathLst>
              <a:path w="2135" h="91">
                <a:moveTo>
                  <a:pt x="2135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591080" y="2527200"/>
            <a:ext cx="168120" cy="76320"/>
          </a:xfrm>
          <a:custGeom>
            <a:avLst/>
            <a:gdLst/>
            <a:ahLst/>
            <a:rect l="l" t="t" r="r" b="b"/>
            <a:pathLst>
              <a:path w="422" h="159">
                <a:moveTo>
                  <a:pt x="422" y="0"/>
                </a:moveTo>
                <a:lnTo>
                  <a:pt x="0" y="0"/>
                </a:lnTo>
                <a:lnTo>
                  <a:pt x="0" y="159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911760" y="1521000"/>
            <a:ext cx="368280" cy="285480"/>
          </a:xfrm>
          <a:custGeom>
            <a:avLst/>
            <a:gdLst/>
            <a:ahLst/>
            <a:rect l="l" t="t" r="r" b="b"/>
            <a:pathLst>
              <a:path w="922" h="594">
                <a:moveTo>
                  <a:pt x="922" y="0"/>
                </a:moveTo>
                <a:lnTo>
                  <a:pt x="0" y="0"/>
                </a:lnTo>
                <a:lnTo>
                  <a:pt x="0" y="594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954680" y="1719360"/>
            <a:ext cx="338040" cy="44280"/>
          </a:xfrm>
          <a:custGeom>
            <a:avLst/>
            <a:gdLst/>
            <a:ahLst/>
            <a:rect l="l" t="t" r="r" b="b"/>
            <a:pathLst>
              <a:path w="847" h="91">
                <a:moveTo>
                  <a:pt x="847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08000" y="3330720"/>
            <a:ext cx="2752560" cy="1390680"/>
          </a:xfrm>
          <a:custGeom>
            <a:avLst/>
            <a:gdLst/>
            <a:ahLst/>
            <a:rect l="l" t="t" r="r" b="b"/>
            <a:pathLst>
              <a:path w="6884" h="2899">
                <a:moveTo>
                  <a:pt x="6884" y="0"/>
                </a:moveTo>
                <a:lnTo>
                  <a:pt x="0" y="0"/>
                </a:lnTo>
                <a:lnTo>
                  <a:pt x="0" y="2899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105440" y="6372360"/>
            <a:ext cx="190440" cy="171360"/>
          </a:xfrm>
          <a:custGeom>
            <a:avLst/>
            <a:gdLst/>
            <a:ahLst/>
            <a:rect l="l" t="t" r="r" b="b"/>
            <a:pathLst>
              <a:path w="475" h="358">
                <a:moveTo>
                  <a:pt x="475" y="358"/>
                </a:moveTo>
                <a:lnTo>
                  <a:pt x="0" y="358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759200" y="2527200"/>
            <a:ext cx="609840" cy="65160"/>
          </a:xfrm>
          <a:custGeom>
            <a:avLst/>
            <a:gdLst/>
            <a:ahLst/>
            <a:rect l="l" t="t" r="r" b="b"/>
            <a:pathLst>
              <a:path w="1526" h="136">
                <a:moveTo>
                  <a:pt x="1526" y="136"/>
                </a:moveTo>
                <a:lnTo>
                  <a:pt x="0" y="136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940280" y="1501920"/>
            <a:ext cx="449280" cy="42840"/>
          </a:xfrm>
          <a:custGeom>
            <a:avLst/>
            <a:gdLst/>
            <a:ahLst/>
            <a:rect l="l" t="t" r="r" b="b"/>
            <a:pathLst>
              <a:path w="1122" h="91">
                <a:moveTo>
                  <a:pt x="1122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660840" y="6534000"/>
            <a:ext cx="1466640" cy="163800"/>
          </a:xfrm>
          <a:custGeom>
            <a:avLst/>
            <a:gdLst/>
            <a:ahLst/>
            <a:rect l="l" t="t" r="r" b="b"/>
            <a:pathLst>
              <a:path w="3667" h="339">
                <a:moveTo>
                  <a:pt x="3667" y="339"/>
                </a:moveTo>
                <a:lnTo>
                  <a:pt x="0" y="339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5246640" y="2766960"/>
            <a:ext cx="17640" cy="44640"/>
          </a:xfrm>
          <a:custGeom>
            <a:avLst/>
            <a:gdLst/>
            <a:ahLst/>
            <a:rect l="l" t="t" r="r" b="b"/>
            <a:pathLst>
              <a:path w="41" h="91">
                <a:moveTo>
                  <a:pt x="41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5392800" y="4863960"/>
            <a:ext cx="33120" cy="42840"/>
          </a:xfrm>
          <a:custGeom>
            <a:avLst/>
            <a:gdLst/>
            <a:ahLst/>
            <a:rect l="l" t="t" r="r" b="b"/>
            <a:pathLst>
              <a:path w="80" h="90">
                <a:moveTo>
                  <a:pt x="80" y="0"/>
                </a:moveTo>
                <a:lnTo>
                  <a:pt x="0" y="0"/>
                </a:lnTo>
                <a:lnTo>
                  <a:pt x="0" y="9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844880" y="6478560"/>
            <a:ext cx="11160" cy="44640"/>
          </a:xfrm>
          <a:custGeom>
            <a:avLst/>
            <a:gdLst/>
            <a:ahLst/>
            <a:rect l="l" t="t" r="r" b="b"/>
            <a:pathLst>
              <a:path w="29" h="91">
                <a:moveTo>
                  <a:pt x="29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846680" y="1501920"/>
            <a:ext cx="93600" cy="64800"/>
          </a:xfrm>
          <a:custGeom>
            <a:avLst/>
            <a:gdLst/>
            <a:ahLst/>
            <a:rect l="l" t="t" r="r" b="b"/>
            <a:pathLst>
              <a:path w="235" h="137">
                <a:moveTo>
                  <a:pt x="235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08000" y="4721400"/>
            <a:ext cx="2752560" cy="1392120"/>
          </a:xfrm>
          <a:custGeom>
            <a:avLst/>
            <a:gdLst/>
            <a:ahLst/>
            <a:rect l="l" t="t" r="r" b="b"/>
            <a:pathLst>
              <a:path w="6884" h="2899">
                <a:moveTo>
                  <a:pt x="6884" y="2899"/>
                </a:moveTo>
                <a:lnTo>
                  <a:pt x="0" y="2899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5079960" y="4338720"/>
            <a:ext cx="219240" cy="44280"/>
          </a:xfrm>
          <a:custGeom>
            <a:avLst/>
            <a:gdLst/>
            <a:ahLst/>
            <a:rect l="l" t="t" r="r" b="b"/>
            <a:pathLst>
              <a:path w="549" h="91">
                <a:moveTo>
                  <a:pt x="549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965840" y="2462040"/>
            <a:ext cx="463320" cy="43200"/>
          </a:xfrm>
          <a:custGeom>
            <a:avLst/>
            <a:gdLst/>
            <a:ahLst/>
            <a:rect l="l" t="t" r="r" b="b"/>
            <a:pathLst>
              <a:path w="1161" h="91">
                <a:moveTo>
                  <a:pt x="1161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667400" y="6303960"/>
            <a:ext cx="15840" cy="44280"/>
          </a:xfrm>
          <a:custGeom>
            <a:avLst/>
            <a:gdLst/>
            <a:ahLst/>
            <a:rect l="l" t="t" r="r" b="b"/>
            <a:pathLst>
              <a:path w="40" h="91">
                <a:moveTo>
                  <a:pt x="40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295880" y="6543720"/>
            <a:ext cx="631800" cy="66600"/>
          </a:xfrm>
          <a:custGeom>
            <a:avLst/>
            <a:gdLst/>
            <a:ahLst/>
            <a:rect l="l" t="t" r="r" b="b"/>
            <a:pathLst>
              <a:path w="1580" h="137">
                <a:moveTo>
                  <a:pt x="1580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681440" y="5954760"/>
            <a:ext cx="15840" cy="65160"/>
          </a:xfrm>
          <a:custGeom>
            <a:avLst/>
            <a:gdLst/>
            <a:ahLst/>
            <a:rect l="l" t="t" r="r" b="b"/>
            <a:pathLst>
              <a:path w="40" h="137">
                <a:moveTo>
                  <a:pt x="40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860560" y="5692680"/>
            <a:ext cx="1211400" cy="420840"/>
          </a:xfrm>
          <a:custGeom>
            <a:avLst/>
            <a:gdLst/>
            <a:ahLst/>
            <a:rect l="l" t="t" r="r" b="b"/>
            <a:pathLst>
              <a:path w="3026" h="876">
                <a:moveTo>
                  <a:pt x="3026" y="0"/>
                </a:moveTo>
                <a:lnTo>
                  <a:pt x="0" y="0"/>
                </a:lnTo>
                <a:lnTo>
                  <a:pt x="0" y="876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432320" y="3728880"/>
            <a:ext cx="663480" cy="43200"/>
          </a:xfrm>
          <a:custGeom>
            <a:avLst/>
            <a:gdLst/>
            <a:ahLst/>
            <a:rect l="l" t="t" r="r" b="b"/>
            <a:pathLst>
              <a:path w="1659" h="91">
                <a:moveTo>
                  <a:pt x="1659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2860560" y="2932200"/>
            <a:ext cx="262080" cy="398520"/>
          </a:xfrm>
          <a:custGeom>
            <a:avLst/>
            <a:gdLst/>
            <a:ahLst/>
            <a:rect l="l" t="t" r="r" b="b"/>
            <a:pathLst>
              <a:path w="654" h="828">
                <a:moveTo>
                  <a:pt x="654" y="0"/>
                </a:moveTo>
                <a:lnTo>
                  <a:pt x="0" y="0"/>
                </a:lnTo>
                <a:lnTo>
                  <a:pt x="0" y="828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5384880" y="4689360"/>
            <a:ext cx="119160" cy="42840"/>
          </a:xfrm>
          <a:custGeom>
            <a:avLst/>
            <a:gdLst/>
            <a:ahLst/>
            <a:rect l="l" t="t" r="r" b="b"/>
            <a:pathLst>
              <a:path w="296" h="91">
                <a:moveTo>
                  <a:pt x="296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308480" y="3836880"/>
            <a:ext cx="592200" cy="66960"/>
          </a:xfrm>
          <a:custGeom>
            <a:avLst/>
            <a:gdLst/>
            <a:ahLst/>
            <a:rect l="l" t="t" r="r" b="b"/>
            <a:pathLst>
              <a:path w="1480" h="137">
                <a:moveTo>
                  <a:pt x="1480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911760" y="1806480"/>
            <a:ext cx="88920" cy="284400"/>
          </a:xfrm>
          <a:custGeom>
            <a:avLst/>
            <a:gdLst/>
            <a:ahLst/>
            <a:rect l="l" t="t" r="r" b="b"/>
            <a:pathLst>
              <a:path w="223" h="594">
                <a:moveTo>
                  <a:pt x="223" y="594"/>
                </a:moveTo>
                <a:lnTo>
                  <a:pt x="0" y="594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5411880" y="4513320"/>
            <a:ext cx="39600" cy="44280"/>
          </a:xfrm>
          <a:custGeom>
            <a:avLst/>
            <a:gdLst/>
            <a:ahLst/>
            <a:rect l="l" t="t" r="r" b="b"/>
            <a:pathLst>
              <a:path w="99" h="91">
                <a:moveTo>
                  <a:pt x="99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338720" y="5605560"/>
            <a:ext cx="31680" cy="44280"/>
          </a:xfrm>
          <a:custGeom>
            <a:avLst/>
            <a:gdLst/>
            <a:ahLst/>
            <a:rect l="l" t="t" r="r" b="b"/>
            <a:pathLst>
              <a:path w="76" h="91">
                <a:moveTo>
                  <a:pt x="76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924360" y="3989520"/>
            <a:ext cx="1077840" cy="172800"/>
          </a:xfrm>
          <a:custGeom>
            <a:avLst/>
            <a:gdLst/>
            <a:ahLst/>
            <a:rect l="l" t="t" r="r" b="b"/>
            <a:pathLst>
              <a:path w="2694" h="359">
                <a:moveTo>
                  <a:pt x="2694" y="0"/>
                </a:moveTo>
                <a:lnTo>
                  <a:pt x="0" y="0"/>
                </a:lnTo>
                <a:lnTo>
                  <a:pt x="0" y="359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832200" y="2125800"/>
            <a:ext cx="133200" cy="320400"/>
          </a:xfrm>
          <a:custGeom>
            <a:avLst/>
            <a:gdLst/>
            <a:ahLst/>
            <a:rect l="l" t="t" r="r" b="b"/>
            <a:pathLst>
              <a:path w="334" h="666">
                <a:moveTo>
                  <a:pt x="334" y="666"/>
                </a:moveTo>
                <a:lnTo>
                  <a:pt x="0" y="666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5197320" y="5430960"/>
            <a:ext cx="71640" cy="44280"/>
          </a:xfrm>
          <a:custGeom>
            <a:avLst/>
            <a:gdLst/>
            <a:ahLst/>
            <a:rect l="l" t="t" r="r" b="b"/>
            <a:pathLst>
              <a:path w="178" h="91">
                <a:moveTo>
                  <a:pt x="178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4572000" y="6095880"/>
            <a:ext cx="92160" cy="104760"/>
          </a:xfrm>
          <a:custGeom>
            <a:avLst/>
            <a:gdLst/>
            <a:ahLst/>
            <a:rect l="l" t="t" r="r" b="b"/>
            <a:pathLst>
              <a:path w="230" h="216">
                <a:moveTo>
                  <a:pt x="230" y="0"/>
                </a:moveTo>
                <a:lnTo>
                  <a:pt x="0" y="0"/>
                </a:lnTo>
                <a:lnTo>
                  <a:pt x="0" y="216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781440" y="3836880"/>
            <a:ext cx="527040" cy="163800"/>
          </a:xfrm>
          <a:custGeom>
            <a:avLst/>
            <a:gdLst/>
            <a:ahLst/>
            <a:rect l="l" t="t" r="r" b="b"/>
            <a:pathLst>
              <a:path w="1319" h="339">
                <a:moveTo>
                  <a:pt x="1319" y="0"/>
                </a:moveTo>
                <a:lnTo>
                  <a:pt x="0" y="0"/>
                </a:lnTo>
                <a:lnTo>
                  <a:pt x="0" y="339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954680" y="1763640"/>
            <a:ext cx="276120" cy="42840"/>
          </a:xfrm>
          <a:custGeom>
            <a:avLst/>
            <a:gdLst/>
            <a:ahLst/>
            <a:rect l="l" t="t" r="r" b="b"/>
            <a:pathLst>
              <a:path w="691" h="91">
                <a:moveTo>
                  <a:pt x="691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3443400" y="3073320"/>
            <a:ext cx="834840" cy="87480"/>
          </a:xfrm>
          <a:custGeom>
            <a:avLst/>
            <a:gdLst/>
            <a:ahLst/>
            <a:rect l="l" t="t" r="r" b="b"/>
            <a:pathLst>
              <a:path w="2086" h="182">
                <a:moveTo>
                  <a:pt x="2086" y="0"/>
                </a:moveTo>
                <a:lnTo>
                  <a:pt x="0" y="0"/>
                </a:lnTo>
                <a:lnTo>
                  <a:pt x="0" y="182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392800" y="4906800"/>
            <a:ext cx="28440" cy="43200"/>
          </a:xfrm>
          <a:custGeom>
            <a:avLst/>
            <a:gdLst/>
            <a:ahLst/>
            <a:rect l="l" t="t" r="r" b="b"/>
            <a:pathLst>
              <a:path w="70" h="91">
                <a:moveTo>
                  <a:pt x="70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781440" y="4000680"/>
            <a:ext cx="142920" cy="161640"/>
          </a:xfrm>
          <a:custGeom>
            <a:avLst/>
            <a:gdLst/>
            <a:ahLst/>
            <a:rect l="l" t="t" r="r" b="b"/>
            <a:pathLst>
              <a:path w="357" h="338">
                <a:moveTo>
                  <a:pt x="357" y="338"/>
                </a:moveTo>
                <a:lnTo>
                  <a:pt x="0" y="338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52560" y="4721400"/>
            <a:ext cx="55440" cy="1440"/>
          </a:xfrm>
          <a:prstGeom prst="line">
            <a:avLst/>
          </a:prstGeom>
          <a:ln cap="rnd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3924360" y="4162320"/>
            <a:ext cx="457200" cy="171720"/>
          </a:xfrm>
          <a:custGeom>
            <a:avLst/>
            <a:gdLst/>
            <a:ahLst/>
            <a:rect l="l" t="t" r="r" b="b"/>
            <a:pathLst>
              <a:path w="1143" h="358">
                <a:moveTo>
                  <a:pt x="1143" y="358"/>
                </a:moveTo>
                <a:lnTo>
                  <a:pt x="0" y="358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4103640" y="2243160"/>
            <a:ext cx="1054080" cy="44280"/>
          </a:xfrm>
          <a:custGeom>
            <a:avLst/>
            <a:gdLst/>
            <a:ahLst/>
            <a:rect l="l" t="t" r="r" b="b"/>
            <a:pathLst>
              <a:path w="2634" h="91">
                <a:moveTo>
                  <a:pt x="2634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4849920" y="5175360"/>
            <a:ext cx="447480" cy="123840"/>
          </a:xfrm>
          <a:custGeom>
            <a:avLst/>
            <a:gdLst/>
            <a:ahLst/>
            <a:rect l="l" t="t" r="r" b="b"/>
            <a:pathLst>
              <a:path w="1119" h="261">
                <a:moveTo>
                  <a:pt x="1119" y="261"/>
                </a:moveTo>
                <a:lnTo>
                  <a:pt x="0" y="26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4278240" y="3073320"/>
            <a:ext cx="758880" cy="42840"/>
          </a:xfrm>
          <a:custGeom>
            <a:avLst/>
            <a:gdLst/>
            <a:ahLst/>
            <a:rect l="l" t="t" r="r" b="b"/>
            <a:pathLst>
              <a:path w="1897" h="91">
                <a:moveTo>
                  <a:pt x="1897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4759200" y="2462040"/>
            <a:ext cx="206640" cy="65160"/>
          </a:xfrm>
          <a:custGeom>
            <a:avLst/>
            <a:gdLst/>
            <a:ahLst/>
            <a:rect l="l" t="t" r="r" b="b"/>
            <a:pathLst>
              <a:path w="516" h="137">
                <a:moveTo>
                  <a:pt x="516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224160" y="3454560"/>
            <a:ext cx="976320" cy="272880"/>
          </a:xfrm>
          <a:custGeom>
            <a:avLst/>
            <a:gdLst/>
            <a:ahLst/>
            <a:rect l="l" t="t" r="r" b="b"/>
            <a:pathLst>
              <a:path w="2441" h="567">
                <a:moveTo>
                  <a:pt x="2441" y="0"/>
                </a:moveTo>
                <a:lnTo>
                  <a:pt x="0" y="0"/>
                </a:lnTo>
                <a:lnTo>
                  <a:pt x="0" y="567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860560" y="6113520"/>
            <a:ext cx="800280" cy="420480"/>
          </a:xfrm>
          <a:custGeom>
            <a:avLst/>
            <a:gdLst/>
            <a:ahLst/>
            <a:rect l="l" t="t" r="r" b="b"/>
            <a:pathLst>
              <a:path w="1999" h="877">
                <a:moveTo>
                  <a:pt x="1999" y="877"/>
                </a:moveTo>
                <a:lnTo>
                  <a:pt x="0" y="877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4200480" y="3454560"/>
            <a:ext cx="327240" cy="77760"/>
          </a:xfrm>
          <a:custGeom>
            <a:avLst/>
            <a:gdLst/>
            <a:ahLst/>
            <a:rect l="l" t="t" r="r" b="b"/>
            <a:pathLst>
              <a:path w="815" h="159">
                <a:moveTo>
                  <a:pt x="815" y="159"/>
                </a:moveTo>
                <a:lnTo>
                  <a:pt x="0" y="159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4572000" y="4383000"/>
            <a:ext cx="507960" cy="460440"/>
          </a:xfrm>
          <a:custGeom>
            <a:avLst/>
            <a:gdLst/>
            <a:ahLst/>
            <a:rect l="l" t="t" r="r" b="b"/>
            <a:pathLst>
              <a:path w="1267" h="958">
                <a:moveTo>
                  <a:pt x="1267" y="0"/>
                </a:moveTo>
                <a:lnTo>
                  <a:pt x="0" y="0"/>
                </a:lnTo>
                <a:lnTo>
                  <a:pt x="0" y="958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527720" y="3532320"/>
            <a:ext cx="226800" cy="64800"/>
          </a:xfrm>
          <a:custGeom>
            <a:avLst/>
            <a:gdLst/>
            <a:ahLst/>
            <a:rect l="l" t="t" r="r" b="b"/>
            <a:pathLst>
              <a:path w="567" h="137">
                <a:moveTo>
                  <a:pt x="567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660840" y="6372360"/>
            <a:ext cx="444600" cy="161640"/>
          </a:xfrm>
          <a:custGeom>
            <a:avLst/>
            <a:gdLst/>
            <a:ahLst/>
            <a:rect l="l" t="t" r="r" b="b"/>
            <a:pathLst>
              <a:path w="1113" h="338">
                <a:moveTo>
                  <a:pt x="1113" y="0"/>
                </a:moveTo>
                <a:lnTo>
                  <a:pt x="0" y="0"/>
                </a:lnTo>
                <a:lnTo>
                  <a:pt x="0" y="338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4432320" y="3772080"/>
            <a:ext cx="560520" cy="44280"/>
          </a:xfrm>
          <a:custGeom>
            <a:avLst/>
            <a:gdLst/>
            <a:ahLst/>
            <a:rect l="l" t="t" r="r" b="b"/>
            <a:pathLst>
              <a:path w="1401" h="91">
                <a:moveTo>
                  <a:pt x="1401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5197320" y="5386320"/>
            <a:ext cx="98640" cy="44640"/>
          </a:xfrm>
          <a:custGeom>
            <a:avLst/>
            <a:gdLst/>
            <a:ahLst/>
            <a:rect l="l" t="t" r="r" b="b"/>
            <a:pathLst>
              <a:path w="245" h="91">
                <a:moveTo>
                  <a:pt x="245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4591080" y="2603520"/>
            <a:ext cx="573120" cy="76320"/>
          </a:xfrm>
          <a:custGeom>
            <a:avLst/>
            <a:gdLst/>
            <a:ahLst/>
            <a:rect l="l" t="t" r="r" b="b"/>
            <a:pathLst>
              <a:path w="1434" h="159">
                <a:moveTo>
                  <a:pt x="1434" y="159"/>
                </a:moveTo>
                <a:lnTo>
                  <a:pt x="0" y="159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4846680" y="1566720"/>
            <a:ext cx="441360" cy="65160"/>
          </a:xfrm>
          <a:custGeom>
            <a:avLst/>
            <a:gdLst/>
            <a:ahLst/>
            <a:rect l="l" t="t" r="r" b="b"/>
            <a:pathLst>
              <a:path w="1103" h="136">
                <a:moveTo>
                  <a:pt x="1103" y="136"/>
                </a:moveTo>
                <a:lnTo>
                  <a:pt x="0" y="136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4338720" y="5562720"/>
            <a:ext cx="50760" cy="42840"/>
          </a:xfrm>
          <a:custGeom>
            <a:avLst/>
            <a:gdLst/>
            <a:ahLst/>
            <a:rect l="l" t="t" r="r" b="b"/>
            <a:pathLst>
              <a:path w="127" h="91">
                <a:moveTo>
                  <a:pt x="127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5300640" y="4819680"/>
            <a:ext cx="92160" cy="87120"/>
          </a:xfrm>
          <a:custGeom>
            <a:avLst/>
            <a:gdLst/>
            <a:ahLst/>
            <a:rect l="l" t="t" r="r" b="b"/>
            <a:pathLst>
              <a:path w="232" h="181">
                <a:moveTo>
                  <a:pt x="232" y="181"/>
                </a:moveTo>
                <a:lnTo>
                  <a:pt x="0" y="18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483000" y="2468520"/>
            <a:ext cx="128520" cy="236520"/>
          </a:xfrm>
          <a:custGeom>
            <a:avLst/>
            <a:gdLst/>
            <a:ahLst/>
            <a:rect l="l" t="t" r="r" b="b"/>
            <a:pathLst>
              <a:path w="322" h="493">
                <a:moveTo>
                  <a:pt x="322" y="0"/>
                </a:moveTo>
                <a:lnTo>
                  <a:pt x="0" y="0"/>
                </a:lnTo>
                <a:lnTo>
                  <a:pt x="0" y="493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4529160" y="4121280"/>
            <a:ext cx="669960" cy="42840"/>
          </a:xfrm>
          <a:custGeom>
            <a:avLst/>
            <a:gdLst/>
            <a:ahLst/>
            <a:rect l="l" t="t" r="r" b="b"/>
            <a:pathLst>
              <a:path w="1677" h="91">
                <a:moveTo>
                  <a:pt x="1677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4667400" y="6259680"/>
            <a:ext cx="20520" cy="44280"/>
          </a:xfrm>
          <a:custGeom>
            <a:avLst/>
            <a:gdLst/>
            <a:ahLst/>
            <a:rect l="l" t="t" r="r" b="b"/>
            <a:pathLst>
              <a:path w="51" h="91">
                <a:moveTo>
                  <a:pt x="51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4278240" y="3030480"/>
            <a:ext cx="654120" cy="42840"/>
          </a:xfrm>
          <a:custGeom>
            <a:avLst/>
            <a:gdLst/>
            <a:ahLst/>
            <a:rect l="l" t="t" r="r" b="b"/>
            <a:pathLst>
              <a:path w="1635" h="90">
                <a:moveTo>
                  <a:pt x="1635" y="0"/>
                </a:moveTo>
                <a:lnTo>
                  <a:pt x="0" y="0"/>
                </a:lnTo>
                <a:lnTo>
                  <a:pt x="0" y="9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5411880" y="4557600"/>
            <a:ext cx="58680" cy="44640"/>
          </a:xfrm>
          <a:custGeom>
            <a:avLst/>
            <a:gdLst/>
            <a:ahLst/>
            <a:rect l="l" t="t" r="r" b="b"/>
            <a:pathLst>
              <a:path w="146" h="91">
                <a:moveTo>
                  <a:pt x="146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4370400" y="1779480"/>
            <a:ext cx="690480" cy="114480"/>
          </a:xfrm>
          <a:custGeom>
            <a:avLst/>
            <a:gdLst/>
            <a:ahLst/>
            <a:rect l="l" t="t" r="r" b="b"/>
            <a:pathLst>
              <a:path w="1729" h="239">
                <a:moveTo>
                  <a:pt x="1729" y="239"/>
                </a:moveTo>
                <a:lnTo>
                  <a:pt x="0" y="239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4202280" y="2025720"/>
            <a:ext cx="838080" cy="44280"/>
          </a:xfrm>
          <a:custGeom>
            <a:avLst/>
            <a:gdLst/>
            <a:ahLst/>
            <a:rect l="l" t="t" r="r" b="b"/>
            <a:pathLst>
              <a:path w="2094" h="91">
                <a:moveTo>
                  <a:pt x="2094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4781520" y="5737320"/>
            <a:ext cx="490680" cy="42840"/>
          </a:xfrm>
          <a:custGeom>
            <a:avLst/>
            <a:gdLst/>
            <a:ahLst/>
            <a:rect l="l" t="t" r="r" b="b"/>
            <a:pathLst>
              <a:path w="1227" h="90">
                <a:moveTo>
                  <a:pt x="1227" y="0"/>
                </a:moveTo>
                <a:lnTo>
                  <a:pt x="0" y="0"/>
                </a:lnTo>
                <a:lnTo>
                  <a:pt x="0" y="9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4375080" y="1262160"/>
            <a:ext cx="330120" cy="65160"/>
          </a:xfrm>
          <a:custGeom>
            <a:avLst/>
            <a:gdLst/>
            <a:ahLst/>
            <a:rect l="l" t="t" r="r" b="b"/>
            <a:pathLst>
              <a:path w="828" h="136">
                <a:moveTo>
                  <a:pt x="828" y="136"/>
                </a:moveTo>
                <a:lnTo>
                  <a:pt x="0" y="136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5178600" y="4689360"/>
            <a:ext cx="60120" cy="195480"/>
          </a:xfrm>
          <a:custGeom>
            <a:avLst/>
            <a:gdLst/>
            <a:ahLst/>
            <a:rect l="l" t="t" r="r" b="b"/>
            <a:pathLst>
              <a:path w="153" h="409">
                <a:moveTo>
                  <a:pt x="153" y="0"/>
                </a:moveTo>
                <a:lnTo>
                  <a:pt x="0" y="0"/>
                </a:lnTo>
                <a:lnTo>
                  <a:pt x="0" y="409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122640" y="2932200"/>
            <a:ext cx="320760" cy="228600"/>
          </a:xfrm>
          <a:custGeom>
            <a:avLst/>
            <a:gdLst/>
            <a:ahLst/>
            <a:rect l="l" t="t" r="r" b="b"/>
            <a:pathLst>
              <a:path w="803" h="474">
                <a:moveTo>
                  <a:pt x="803" y="474"/>
                </a:moveTo>
                <a:lnTo>
                  <a:pt x="0" y="474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202280" y="1981080"/>
            <a:ext cx="852480" cy="44640"/>
          </a:xfrm>
          <a:custGeom>
            <a:avLst/>
            <a:gdLst/>
            <a:ahLst/>
            <a:rect l="l" t="t" r="r" b="b"/>
            <a:pathLst>
              <a:path w="2128" h="91">
                <a:moveTo>
                  <a:pt x="2128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527720" y="3465360"/>
            <a:ext cx="1015920" cy="66960"/>
          </a:xfrm>
          <a:custGeom>
            <a:avLst/>
            <a:gdLst/>
            <a:ahLst/>
            <a:rect l="l" t="t" r="r" b="b"/>
            <a:pathLst>
              <a:path w="2540" h="136">
                <a:moveTo>
                  <a:pt x="2540" y="0"/>
                </a:moveTo>
                <a:lnTo>
                  <a:pt x="0" y="0"/>
                </a:lnTo>
                <a:lnTo>
                  <a:pt x="0" y="136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5235480" y="5037120"/>
            <a:ext cx="168480" cy="44640"/>
          </a:xfrm>
          <a:custGeom>
            <a:avLst/>
            <a:gdLst/>
            <a:ahLst/>
            <a:rect l="l" t="t" r="r" b="b"/>
            <a:pathLst>
              <a:path w="418" h="91">
                <a:moveTo>
                  <a:pt x="418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4375080" y="1197000"/>
            <a:ext cx="825480" cy="65160"/>
          </a:xfrm>
          <a:custGeom>
            <a:avLst/>
            <a:gdLst/>
            <a:ahLst/>
            <a:rect l="l" t="t" r="r" b="b"/>
            <a:pathLst>
              <a:path w="2066" h="136">
                <a:moveTo>
                  <a:pt x="2066" y="0"/>
                </a:moveTo>
                <a:lnTo>
                  <a:pt x="0" y="0"/>
                </a:lnTo>
                <a:lnTo>
                  <a:pt x="0" y="136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4451400" y="4251240"/>
            <a:ext cx="720720" cy="297000"/>
          </a:xfrm>
          <a:custGeom>
            <a:avLst/>
            <a:gdLst/>
            <a:ahLst/>
            <a:rect l="l" t="t" r="r" b="b"/>
            <a:pathLst>
              <a:path w="1800" h="616">
                <a:moveTo>
                  <a:pt x="1800" y="0"/>
                </a:moveTo>
                <a:lnTo>
                  <a:pt x="0" y="0"/>
                </a:lnTo>
                <a:lnTo>
                  <a:pt x="0" y="616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4691160" y="5175360"/>
            <a:ext cx="158760" cy="126720"/>
          </a:xfrm>
          <a:custGeom>
            <a:avLst/>
            <a:gdLst/>
            <a:ahLst/>
            <a:rect l="l" t="t" r="r" b="b"/>
            <a:pathLst>
              <a:path w="397" h="267">
                <a:moveTo>
                  <a:pt x="397" y="0"/>
                </a:moveTo>
                <a:lnTo>
                  <a:pt x="0" y="0"/>
                </a:lnTo>
                <a:lnTo>
                  <a:pt x="0" y="267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4691160" y="5302080"/>
            <a:ext cx="506160" cy="128880"/>
          </a:xfrm>
          <a:custGeom>
            <a:avLst/>
            <a:gdLst/>
            <a:ahLst/>
            <a:rect l="l" t="t" r="r" b="b"/>
            <a:pathLst>
              <a:path w="1268" h="267">
                <a:moveTo>
                  <a:pt x="1268" y="267"/>
                </a:moveTo>
                <a:lnTo>
                  <a:pt x="0" y="267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4529160" y="4076640"/>
            <a:ext cx="644400" cy="44640"/>
          </a:xfrm>
          <a:custGeom>
            <a:avLst/>
            <a:gdLst/>
            <a:ahLst/>
            <a:rect l="l" t="t" r="r" b="b"/>
            <a:pathLst>
              <a:path w="1615" h="91">
                <a:moveTo>
                  <a:pt x="1615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4200480" y="3378240"/>
            <a:ext cx="1258920" cy="76320"/>
          </a:xfrm>
          <a:custGeom>
            <a:avLst/>
            <a:gdLst/>
            <a:ahLst/>
            <a:rect l="l" t="t" r="r" b="b"/>
            <a:pathLst>
              <a:path w="3145" h="159">
                <a:moveTo>
                  <a:pt x="3145" y="0"/>
                </a:moveTo>
                <a:lnTo>
                  <a:pt x="0" y="0"/>
                </a:lnTo>
                <a:lnTo>
                  <a:pt x="0" y="159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4103640" y="2287440"/>
            <a:ext cx="825480" cy="42840"/>
          </a:xfrm>
          <a:custGeom>
            <a:avLst/>
            <a:gdLst/>
            <a:ahLst/>
            <a:rect l="l" t="t" r="r" b="b"/>
            <a:pathLst>
              <a:path w="2064" h="91">
                <a:moveTo>
                  <a:pt x="2064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5300640" y="4732200"/>
            <a:ext cx="84240" cy="87480"/>
          </a:xfrm>
          <a:custGeom>
            <a:avLst/>
            <a:gdLst/>
            <a:ahLst/>
            <a:rect l="l" t="t" r="r" b="b"/>
            <a:pathLst>
              <a:path w="210" h="182">
                <a:moveTo>
                  <a:pt x="210" y="0"/>
                </a:moveTo>
                <a:lnTo>
                  <a:pt x="0" y="0"/>
                </a:lnTo>
                <a:lnTo>
                  <a:pt x="0" y="182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4000680" y="2090880"/>
            <a:ext cx="1139760" cy="64800"/>
          </a:xfrm>
          <a:custGeom>
            <a:avLst/>
            <a:gdLst/>
            <a:ahLst/>
            <a:rect l="l" t="t" r="r" b="b"/>
            <a:pathLst>
              <a:path w="2848" h="136">
                <a:moveTo>
                  <a:pt x="2848" y="136"/>
                </a:moveTo>
                <a:lnTo>
                  <a:pt x="0" y="136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5238720" y="4689360"/>
            <a:ext cx="61920" cy="130320"/>
          </a:xfrm>
          <a:custGeom>
            <a:avLst/>
            <a:gdLst/>
            <a:ahLst/>
            <a:rect l="l" t="t" r="r" b="b"/>
            <a:pathLst>
              <a:path w="153" h="273">
                <a:moveTo>
                  <a:pt x="153" y="273"/>
                </a:moveTo>
                <a:lnTo>
                  <a:pt x="0" y="273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3805200" y="3247920"/>
            <a:ext cx="851040" cy="42840"/>
          </a:xfrm>
          <a:custGeom>
            <a:avLst/>
            <a:gdLst/>
            <a:ahLst/>
            <a:rect l="l" t="t" r="r" b="b"/>
            <a:pathLst>
              <a:path w="2125" h="91">
                <a:moveTo>
                  <a:pt x="2125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3611520" y="2125800"/>
            <a:ext cx="220680" cy="342720"/>
          </a:xfrm>
          <a:custGeom>
            <a:avLst/>
            <a:gdLst/>
            <a:ahLst/>
            <a:rect l="l" t="t" r="r" b="b"/>
            <a:pathLst>
              <a:path w="552" h="714">
                <a:moveTo>
                  <a:pt x="552" y="0"/>
                </a:moveTo>
                <a:lnTo>
                  <a:pt x="0" y="0"/>
                </a:lnTo>
                <a:lnTo>
                  <a:pt x="0" y="714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4940280" y="1457280"/>
            <a:ext cx="523800" cy="44640"/>
          </a:xfrm>
          <a:custGeom>
            <a:avLst/>
            <a:gdLst/>
            <a:ahLst/>
            <a:rect l="l" t="t" r="r" b="b"/>
            <a:pathLst>
              <a:path w="1310" h="91">
                <a:moveTo>
                  <a:pt x="1310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4781520" y="5780160"/>
            <a:ext cx="871560" cy="42840"/>
          </a:xfrm>
          <a:custGeom>
            <a:avLst/>
            <a:gdLst/>
            <a:ahLst/>
            <a:rect l="l" t="t" r="r" b="b"/>
            <a:pathLst>
              <a:path w="2177" h="91">
                <a:moveTo>
                  <a:pt x="2177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280040" y="1521000"/>
            <a:ext cx="90360" cy="258480"/>
          </a:xfrm>
          <a:custGeom>
            <a:avLst/>
            <a:gdLst/>
            <a:ahLst/>
            <a:rect l="l" t="t" r="r" b="b"/>
            <a:pathLst>
              <a:path w="224" h="540">
                <a:moveTo>
                  <a:pt x="224" y="540"/>
                </a:moveTo>
                <a:lnTo>
                  <a:pt x="0" y="540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4697280" y="5910120"/>
            <a:ext cx="5040" cy="44640"/>
          </a:xfrm>
          <a:custGeom>
            <a:avLst/>
            <a:gdLst/>
            <a:ahLst/>
            <a:rect l="l" t="t" r="r" b="b"/>
            <a:pathLst>
              <a:path w="11" h="91">
                <a:moveTo>
                  <a:pt x="11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2860560" y="3330720"/>
            <a:ext cx="363600" cy="396720"/>
          </a:xfrm>
          <a:custGeom>
            <a:avLst/>
            <a:gdLst/>
            <a:ahLst/>
            <a:rect l="l" t="t" r="r" b="b"/>
            <a:pathLst>
              <a:path w="909" h="827">
                <a:moveTo>
                  <a:pt x="909" y="827"/>
                </a:moveTo>
                <a:lnTo>
                  <a:pt x="0" y="827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3224160" y="3727440"/>
            <a:ext cx="557280" cy="273240"/>
          </a:xfrm>
          <a:custGeom>
            <a:avLst/>
            <a:gdLst/>
            <a:ahLst/>
            <a:rect l="l" t="t" r="r" b="b"/>
            <a:pathLst>
              <a:path w="1392" h="568">
                <a:moveTo>
                  <a:pt x="1392" y="568"/>
                </a:moveTo>
                <a:lnTo>
                  <a:pt x="0" y="568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3122640" y="2705040"/>
            <a:ext cx="360360" cy="227160"/>
          </a:xfrm>
          <a:custGeom>
            <a:avLst/>
            <a:gdLst/>
            <a:ahLst/>
            <a:rect l="l" t="t" r="r" b="b"/>
            <a:pathLst>
              <a:path w="900" h="474">
                <a:moveTo>
                  <a:pt x="900" y="0"/>
                </a:moveTo>
                <a:lnTo>
                  <a:pt x="0" y="0"/>
                </a:lnTo>
                <a:lnTo>
                  <a:pt x="0" y="474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4105440" y="6200640"/>
            <a:ext cx="466560" cy="171720"/>
          </a:xfrm>
          <a:custGeom>
            <a:avLst/>
            <a:gdLst/>
            <a:ahLst/>
            <a:rect l="l" t="t" r="r" b="b"/>
            <a:pathLst>
              <a:path w="1165" h="358">
                <a:moveTo>
                  <a:pt x="1165" y="0"/>
                </a:moveTo>
                <a:lnTo>
                  <a:pt x="0" y="0"/>
                </a:lnTo>
                <a:lnTo>
                  <a:pt x="0" y="358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4280040" y="1262160"/>
            <a:ext cx="95040" cy="258840"/>
          </a:xfrm>
          <a:custGeom>
            <a:avLst/>
            <a:gdLst/>
            <a:ahLst/>
            <a:rect l="l" t="t" r="r" b="b"/>
            <a:pathLst>
              <a:path w="237" h="540">
                <a:moveTo>
                  <a:pt x="237" y="0"/>
                </a:moveTo>
                <a:lnTo>
                  <a:pt x="0" y="0"/>
                </a:lnTo>
                <a:lnTo>
                  <a:pt x="0" y="54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071960" y="5692680"/>
            <a:ext cx="709560" cy="87480"/>
          </a:xfrm>
          <a:custGeom>
            <a:avLst/>
            <a:gdLst/>
            <a:ahLst/>
            <a:rect l="l" t="t" r="r" b="b"/>
            <a:pathLst>
              <a:path w="1775" h="181">
                <a:moveTo>
                  <a:pt x="1775" y="181"/>
                </a:moveTo>
                <a:lnTo>
                  <a:pt x="0" y="18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4754520" y="3597120"/>
            <a:ext cx="754200" cy="42840"/>
          </a:xfrm>
          <a:custGeom>
            <a:avLst/>
            <a:gdLst/>
            <a:ahLst/>
            <a:rect l="l" t="t" r="r" b="b"/>
            <a:pathLst>
              <a:path w="1885" h="91">
                <a:moveTo>
                  <a:pt x="1885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3483000" y="2705040"/>
            <a:ext cx="1395360" cy="238320"/>
          </a:xfrm>
          <a:custGeom>
            <a:avLst/>
            <a:gdLst/>
            <a:ahLst/>
            <a:rect l="l" t="t" r="r" b="b"/>
            <a:pathLst>
              <a:path w="3491" h="494">
                <a:moveTo>
                  <a:pt x="3491" y="494"/>
                </a:moveTo>
                <a:lnTo>
                  <a:pt x="0" y="494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3443400" y="3160800"/>
            <a:ext cx="361800" cy="87120"/>
          </a:xfrm>
          <a:custGeom>
            <a:avLst/>
            <a:gdLst/>
            <a:ahLst/>
            <a:rect l="l" t="t" r="r" b="b"/>
            <a:pathLst>
              <a:path w="904" h="182">
                <a:moveTo>
                  <a:pt x="904" y="182"/>
                </a:moveTo>
                <a:lnTo>
                  <a:pt x="0" y="182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4681440" y="6019920"/>
            <a:ext cx="7920" cy="64800"/>
          </a:xfrm>
          <a:custGeom>
            <a:avLst/>
            <a:gdLst/>
            <a:ahLst/>
            <a:rect l="l" t="t" r="r" b="b"/>
            <a:pathLst>
              <a:path w="18" h="136">
                <a:moveTo>
                  <a:pt x="18" y="136"/>
                </a:moveTo>
                <a:lnTo>
                  <a:pt x="0" y="136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4308480" y="3772080"/>
            <a:ext cx="123840" cy="64800"/>
          </a:xfrm>
          <a:custGeom>
            <a:avLst/>
            <a:gdLst/>
            <a:ahLst/>
            <a:rect l="l" t="t" r="r" b="b"/>
            <a:pathLst>
              <a:path w="308" h="136">
                <a:moveTo>
                  <a:pt x="308" y="0"/>
                </a:moveTo>
                <a:lnTo>
                  <a:pt x="0" y="0"/>
                </a:lnTo>
                <a:lnTo>
                  <a:pt x="0" y="136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3832200" y="1806480"/>
            <a:ext cx="79560" cy="319320"/>
          </a:xfrm>
          <a:custGeom>
            <a:avLst/>
            <a:gdLst/>
            <a:ahLst/>
            <a:rect l="l" t="t" r="r" b="b"/>
            <a:pathLst>
              <a:path w="197" h="667">
                <a:moveTo>
                  <a:pt x="197" y="0"/>
                </a:moveTo>
                <a:lnTo>
                  <a:pt x="0" y="0"/>
                </a:lnTo>
                <a:lnTo>
                  <a:pt x="0" y="667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4630680" y="1665360"/>
            <a:ext cx="324000" cy="98280"/>
          </a:xfrm>
          <a:custGeom>
            <a:avLst/>
            <a:gdLst/>
            <a:ahLst/>
            <a:rect l="l" t="t" r="r" b="b"/>
            <a:pathLst>
              <a:path w="811" h="205">
                <a:moveTo>
                  <a:pt x="811" y="205"/>
                </a:moveTo>
                <a:lnTo>
                  <a:pt x="0" y="205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4295880" y="6478560"/>
            <a:ext cx="549000" cy="65160"/>
          </a:xfrm>
          <a:custGeom>
            <a:avLst/>
            <a:gdLst/>
            <a:ahLst/>
            <a:rect l="l" t="t" r="r" b="b"/>
            <a:pathLst>
              <a:path w="1371" h="136">
                <a:moveTo>
                  <a:pt x="1371" y="0"/>
                </a:moveTo>
                <a:lnTo>
                  <a:pt x="0" y="0"/>
                </a:lnTo>
                <a:lnTo>
                  <a:pt x="0" y="136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4705200" y="1327320"/>
            <a:ext cx="514440" cy="42840"/>
          </a:xfrm>
          <a:custGeom>
            <a:avLst/>
            <a:gdLst/>
            <a:ahLst/>
            <a:rect l="l" t="t" r="r" b="b"/>
            <a:pathLst>
              <a:path w="1284" h="91">
                <a:moveTo>
                  <a:pt x="1284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5238720" y="4557600"/>
            <a:ext cx="173160" cy="131760"/>
          </a:xfrm>
          <a:custGeom>
            <a:avLst/>
            <a:gdLst/>
            <a:ahLst/>
            <a:rect l="l" t="t" r="r" b="b"/>
            <a:pathLst>
              <a:path w="430" h="273">
                <a:moveTo>
                  <a:pt x="430" y="0"/>
                </a:moveTo>
                <a:lnTo>
                  <a:pt x="0" y="0"/>
                </a:lnTo>
                <a:lnTo>
                  <a:pt x="0" y="273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5178600" y="4884840"/>
            <a:ext cx="56880" cy="196920"/>
          </a:xfrm>
          <a:custGeom>
            <a:avLst/>
            <a:gdLst/>
            <a:ahLst/>
            <a:rect l="l" t="t" r="r" b="b"/>
            <a:pathLst>
              <a:path w="145" h="409">
                <a:moveTo>
                  <a:pt x="145" y="409"/>
                </a:moveTo>
                <a:lnTo>
                  <a:pt x="0" y="409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4381560" y="4334040"/>
            <a:ext cx="69840" cy="214200"/>
          </a:xfrm>
          <a:custGeom>
            <a:avLst/>
            <a:gdLst/>
            <a:ahLst/>
            <a:rect l="l" t="t" r="r" b="b"/>
            <a:pathLst>
              <a:path w="175" h="445">
                <a:moveTo>
                  <a:pt x="175" y="445"/>
                </a:moveTo>
                <a:lnTo>
                  <a:pt x="0" y="445"/>
                </a:lnTo>
                <a:lnTo>
                  <a:pt x="0" y="0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4370400" y="1665360"/>
            <a:ext cx="260280" cy="114120"/>
          </a:xfrm>
          <a:custGeom>
            <a:avLst/>
            <a:gdLst/>
            <a:ahLst/>
            <a:rect l="l" t="t" r="r" b="b"/>
            <a:pathLst>
              <a:path w="651" h="239">
                <a:moveTo>
                  <a:pt x="651" y="0"/>
                </a:moveTo>
                <a:lnTo>
                  <a:pt x="0" y="0"/>
                </a:lnTo>
                <a:lnTo>
                  <a:pt x="0" y="239"/>
                </a:lnTo>
              </a:path>
            </a:pathLst>
          </a:custGeom>
          <a:noFill/>
          <a:ln cap="rnd"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4821840" y="14270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0.9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4251960" y="11905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4312080" y="370188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0.9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3799440" y="408780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0.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4867560" y="6485040"/>
            <a:ext cx="78732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ulex theileri flavi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HE574574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4853160" y="6402240"/>
            <a:ext cx="78732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ulex theileri flavi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HE574573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4397760" y="5521320"/>
            <a:ext cx="76572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ell fusing agent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156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4380120" y="5608800"/>
            <a:ext cx="7491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ell fusing agent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GQ1658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5653440" y="5780160"/>
            <a:ext cx="5846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Aedes flavi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AB48840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5141520" y="6659640"/>
            <a:ext cx="5738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Nakiwogo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GQ16580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4929120" y="6576840"/>
            <a:ext cx="60120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Quang Binh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FJ64429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4692960" y="6215040"/>
            <a:ext cx="7365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ulex flavivirus strain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EU87906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4690800" y="6310440"/>
            <a:ext cx="5799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ulex flavi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GQ16580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4695480" y="6134040"/>
            <a:ext cx="56160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ulex flavi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FJ5029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4714560" y="6046920"/>
            <a:ext cx="56160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ulex flavi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FJ66303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4703760" y="5878440"/>
            <a:ext cx="59652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ulex flavi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860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4703400" y="5959440"/>
            <a:ext cx="57852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ulex flavi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AB37721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5200200" y="5641920"/>
            <a:ext cx="843480" cy="1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Kamiti River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506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5461200" y="3330720"/>
            <a:ext cx="45180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Apoi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367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5547240" y="3416400"/>
            <a:ext cx="5050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Modoc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363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5609880" y="3513240"/>
            <a:ext cx="12135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Montana myotis leukoencephalitis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411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5512680" y="3597120"/>
            <a:ext cx="59040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Rio Bravo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367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4932000" y="2989440"/>
            <a:ext cx="6314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Entebbe bat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871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5044320" y="3078000"/>
            <a:ext cx="5187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Yokose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503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4667040" y="3160800"/>
            <a:ext cx="4701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Sepik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871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4656240" y="3252960"/>
            <a:ext cx="6620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Yellow fever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203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5505840" y="4656240"/>
            <a:ext cx="6134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Louping ill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180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5519520" y="4732200"/>
            <a:ext cx="99900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Spanish sheep encephalitis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DQ23515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5418360" y="4826160"/>
            <a:ext cx="9363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Tick-borne encephalitis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167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5420160" y="4906800"/>
            <a:ext cx="87552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Tick-borne encephalitis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U3929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5461560" y="4471920"/>
            <a:ext cx="9183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Greek goat encephalitis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DQ23515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5392440" y="4997520"/>
            <a:ext cx="9136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Tick-borne encephalitis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AF06906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5432040" y="5081760"/>
            <a:ext cx="9183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Tick-borne encephalitis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AB06206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5373000" y="5167440"/>
            <a:ext cx="96840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Omsk hemorrhagic fever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506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5299560" y="5264280"/>
            <a:ext cx="5036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Langat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639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5298120" y="5348160"/>
            <a:ext cx="5842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Alkhurma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435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5268600" y="5430960"/>
            <a:ext cx="9183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Kyasanur forest disease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AY32349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5297400" y="4307040"/>
            <a:ext cx="5403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Deer tick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AF31105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5249520" y="4381560"/>
            <a:ext cx="5752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Powassan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368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5172480" y="4218120"/>
            <a:ext cx="68040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Gadgets Gully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DQ23514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5186880" y="4040280"/>
            <a:ext cx="4942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Karshi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694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5198760" y="4121280"/>
            <a:ext cx="6134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Royal Farm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DQ23514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5003280" y="3941640"/>
            <a:ext cx="49320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Kadam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DQ23514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4900320" y="3865680"/>
            <a:ext cx="5403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Tyuleniy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DQ23514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5095800" y="3689280"/>
            <a:ext cx="5144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Meaban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DQ23514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4998240" y="3778200"/>
            <a:ext cx="70020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Saumarez Reef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DQ2351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4880880" y="2897280"/>
            <a:ext cx="4762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Lammi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FJ60678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5281200" y="2735280"/>
            <a:ext cx="5356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Nounane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EU15942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5272920" y="2811600"/>
            <a:ext cx="5205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Nounane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FJ71116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5494680" y="2378160"/>
            <a:ext cx="6454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Dengue virus type 1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M8751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5428800" y="2467080"/>
            <a:ext cx="6836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Dengue virus type 3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DQ67553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5370840" y="2554200"/>
            <a:ext cx="6454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Dengue virus type 2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M191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5171760" y="2641680"/>
            <a:ext cx="6836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Dengue virus type 4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AY61899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5158800" y="2203560"/>
            <a:ext cx="5738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Kedougou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AY63254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4931280" y="2292480"/>
            <a:ext cx="4226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Zika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EU54598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5056920" y="1943280"/>
            <a:ext cx="62244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Bussuquara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902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5044680" y="2031840"/>
            <a:ext cx="4989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Iguape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902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5144760" y="2117880"/>
            <a:ext cx="57672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Kokobera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902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5235840" y="1244520"/>
            <a:ext cx="48060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Ilheus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902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5220720" y="1327320"/>
            <a:ext cx="46116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Rocio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AY63254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5204880" y="1158840"/>
            <a:ext cx="49752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Bagaza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AY63254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5061600" y="1855800"/>
            <a:ext cx="8830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St. Louis encephalitis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758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5299920" y="1674720"/>
            <a:ext cx="4852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Kunjin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AY27450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5225040" y="1768320"/>
            <a:ext cx="5842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West Nile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156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5470200" y="1413000"/>
            <a:ext cx="87840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Japanese encephalitis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143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5290200" y="1589040"/>
            <a:ext cx="10306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Murray Valley encephalitis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094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5396400" y="1512720"/>
            <a:ext cx="47628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Usutu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NC_00655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4582080" y="125748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4151880" y="144468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785040" y="17366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4507560" y="15937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4829760" y="169380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4245480" y="176688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4082040" y="19591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4472640" y="253368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3983400" y="221760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4845600" y="239220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4639320" y="245736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3878640" y="208440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3494520" y="239400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3845520" y="237348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3362760" y="263520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3000960" y="28591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2742120" y="32576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4155120" y="30020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3318480" y="30877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3682080" y="31813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4408920" y="34592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3659760" y="392580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3097800" y="36529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4637520" y="35258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4185000" y="376560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4082040" y="33829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4408920" y="40496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4964760" y="43070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4259880" y="426240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4332960" y="454968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4456800" y="476568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4728240" y="510228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5070960" y="53546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4942440" y="496728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5263200" y="46562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4570920" y="52261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4655160" y="57103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4221720" y="55292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3950280" y="56167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4443840" y="61135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3983400" y="62881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5182200" y="48229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5118480" y="508176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5066280" y="48038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5291640" y="448956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5118480" y="461016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5475960" y="4557600"/>
            <a:ext cx="996120" cy="8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Turkish sheep encephalitis virus</a:t>
            </a:r>
            <a:r>
              <a:rPr b="0" lang="en-US" sz="500" spc="-1" strike="noStrike" baseline="-25000">
                <a:solidFill>
                  <a:srgbClr val="000000"/>
                </a:solidFill>
                <a:latin typeface="Times New Roman"/>
              </a:rPr>
              <a:t>DQ23515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2742120" y="603576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3539160" y="64562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4177080" y="647064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4717080" y="64087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4540680" y="601992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5128200" y="2728800"/>
            <a:ext cx="113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-27720" y="0"/>
            <a:ext cx="1768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200" spc="-1" strike="noStrike">
                <a:solidFill>
                  <a:srgbClr val="000000"/>
                </a:solidFill>
                <a:latin typeface="Arial"/>
              </a:rPr>
              <a:t>Supplementary data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000000"/>
                </a:solidFill>
                <a:latin typeface="Arial"/>
              </a:rPr>
              <a:t>Parreira 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 flipH="1" flipV="1">
            <a:off x="5657400" y="6462360"/>
            <a:ext cx="157320" cy="255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 flipH="1">
            <a:off x="5654520" y="6488280"/>
            <a:ext cx="160560" cy="489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776160" y="4702320"/>
            <a:ext cx="0" cy="55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1089000" y="4703760"/>
            <a:ext cx="0" cy="55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14T08:36:41Z</dcterms:created>
  <dc:creator>ricardo</dc:creator>
  <dc:description/>
  <dc:language>en-US</dc:language>
  <cp:lastModifiedBy>ricardo</cp:lastModifiedBy>
  <dcterms:modified xsi:type="dcterms:W3CDTF">2012-03-29T14:27:20Z</dcterms:modified>
  <cp:revision>13</cp:revision>
  <dc:subject/>
  <dc:title>Slide 1</dc:title>
</cp:coreProperties>
</file>